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  <p:sldId id="257" r:id="rId4"/>
    <p:sldId id="258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72" r:id="rId14"/>
    <p:sldId id="273" r:id="rId15"/>
    <p:sldId id="274" r:id="rId16"/>
    <p:sldId id="275" r:id="rId17"/>
    <p:sldId id="276" r:id="rId18"/>
    <p:sldId id="280" r:id="rId19"/>
    <p:sldId id="281" r:id="rId20"/>
    <p:sldId id="283" r:id="rId2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53" d="100"/>
          <a:sy n="153" d="100"/>
        </p:scale>
        <p:origin x="-68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printerSettings" Target="printerSettings/printerSettings1.bin"/><Relationship Id="rId23" Type="http://schemas.openxmlformats.org/officeDocument/2006/relationships/presProps" Target="presProps.xml"/><Relationship Id="rId24" Type="http://schemas.openxmlformats.org/officeDocument/2006/relationships/viewProps" Target="viewProps.xml"/><Relationship Id="rId25" Type="http://schemas.openxmlformats.org/officeDocument/2006/relationships/theme" Target="theme/theme1.xml"/><Relationship Id="rId26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26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2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32417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171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8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520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272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521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820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200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095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737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CA" dirty="0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35C38-96DE-7445-B1CA-432D0D67EECD}" type="datetimeFigureOut">
              <a:rPr lang="en-US" smtClean="0"/>
              <a:t>13-02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9C9AD-BAC5-9849-A3A2-9D1E1081EE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30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457200" rtl="0" eaLnBrk="1" latinLnBrk="0" hangingPunct="1">
        <a:spcBef>
          <a:spcPct val="0"/>
        </a:spcBef>
        <a:buNone/>
        <a:defRPr sz="2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3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4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5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6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7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8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8"/>
          <p:cNvSpPr>
            <a:spLocks noGrp="1"/>
          </p:cNvSpPr>
          <p:nvPr>
            <p:ph type="title"/>
          </p:nvPr>
        </p:nvSpPr>
        <p:spPr>
          <a:xfrm>
            <a:off x="0" y="274638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2000" dirty="0" smtClean="0"/>
              <a:t>1. LIQUID FEEDS: REDUCED LACTOSE VS. REGULAR LACTOSE</a:t>
            </a:r>
            <a:br>
              <a:rPr lang="en-US" sz="2000" dirty="0" smtClean="0"/>
            </a:br>
            <a:r>
              <a:rPr lang="en-US" sz="2000" dirty="0" smtClean="0"/>
              <a:t/>
            </a:r>
            <a:br>
              <a:rPr lang="en-US" sz="2000" dirty="0" smtClean="0"/>
            </a:br>
            <a:r>
              <a:rPr lang="en-US" sz="2000" dirty="0" smtClean="0"/>
              <a:t>1.1 DURATION</a:t>
            </a:r>
            <a:endParaRPr lang="en-US" sz="20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86000"/>
            <a:ext cx="91440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05662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3. LACTOSE-FREE LIQUID FEEDS VS. LACTOSE-CONTAINING MIXED DIE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3.2 STOOL OUTPUT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20900"/>
            <a:ext cx="9144000" cy="2607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59660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3. LACTOSE-FREE LIQUID FEEDS VS. LACTOSE-CONTAINING MIXED DIE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3.3 WEIGHT GAIN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20900"/>
            <a:ext cx="9144000" cy="2607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46954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3. LACTOSE-FREE LIQUID FEEDS VS. LACTOSE-CONTAINING MIXED DIE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3.4 TREATMENT FAILUR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79600"/>
            <a:ext cx="9144000" cy="3081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29397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rmAutofit/>
          </a:bodyPr>
          <a:lstStyle/>
          <a:p>
            <a:r>
              <a:rPr lang="en-US" dirty="0"/>
              <a:t>4</a:t>
            </a:r>
            <a:r>
              <a:rPr lang="en-US" dirty="0" smtClean="0"/>
              <a:t>. COMMERCIAL/SPECIALIZED INGREDIENTS VS.</a:t>
            </a:r>
            <a:r>
              <a:rPr lang="en-US" dirty="0"/>
              <a:t> </a:t>
            </a:r>
            <a:r>
              <a:rPr lang="en-US" dirty="0" smtClean="0"/>
              <a:t>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4.1 DURATIO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79600"/>
            <a:ext cx="9144000" cy="3081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90023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rmAutofit/>
          </a:bodyPr>
          <a:lstStyle/>
          <a:p>
            <a:r>
              <a:rPr lang="en-US" dirty="0" smtClean="0"/>
              <a:t>4. COMMERCIAL/SPECIALIZED INGREDIENTS VS. 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4.2 STOOL OUTPUT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41500"/>
            <a:ext cx="9144000" cy="31711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3625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rmAutofit/>
          </a:bodyPr>
          <a:lstStyle/>
          <a:p>
            <a:r>
              <a:rPr lang="en-US" dirty="0" smtClean="0"/>
              <a:t>4. COMMERCIAL/SPECIALIZED INGREDIENTS VS. 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4.3 WEIGHT GA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9100"/>
            <a:ext cx="9144000" cy="3459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9662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8"/>
            <a:ext cx="9144000" cy="1143000"/>
          </a:xfrm>
        </p:spPr>
        <p:txBody>
          <a:bodyPr>
            <a:normAutofit/>
          </a:bodyPr>
          <a:lstStyle/>
          <a:p>
            <a:r>
              <a:rPr lang="en-US" dirty="0" smtClean="0"/>
              <a:t>4. COMMERCIAL/SPECIALIZED INGREDIENTS VS. 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4.4 TREATMENT FAILUR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59514"/>
            <a:ext cx="9144000" cy="4380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228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7"/>
            <a:ext cx="9144000" cy="1371023"/>
          </a:xfrm>
        </p:spPr>
        <p:txBody>
          <a:bodyPr>
            <a:noAutofit/>
          </a:bodyPr>
          <a:lstStyle/>
          <a:p>
            <a:r>
              <a:rPr lang="en-US" dirty="0" smtClean="0"/>
              <a:t>5. LACTOSE-FREE DIETS:</a:t>
            </a:r>
            <a:r>
              <a:rPr lang="en-US" dirty="0"/>
              <a:t> </a:t>
            </a:r>
            <a:r>
              <a:rPr lang="en-US" dirty="0" smtClean="0"/>
              <a:t> </a:t>
            </a:r>
            <a:r>
              <a:rPr lang="en-US" dirty="0"/>
              <a:t/>
            </a:r>
            <a:br>
              <a:rPr lang="en-US" dirty="0"/>
            </a:br>
            <a:r>
              <a:rPr lang="en-US" dirty="0" smtClean="0"/>
              <a:t>COMMERCIAL/SPECIALIZED INGREDIENTS VS.</a:t>
            </a:r>
            <a:r>
              <a:rPr lang="en-US" dirty="0"/>
              <a:t> </a:t>
            </a:r>
            <a:r>
              <a:rPr lang="en-US" dirty="0" smtClean="0"/>
              <a:t>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5.1 DURATION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08200"/>
            <a:ext cx="9144000" cy="2641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32199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7"/>
            <a:ext cx="9144000" cy="1280317"/>
          </a:xfrm>
        </p:spPr>
        <p:txBody>
          <a:bodyPr>
            <a:noAutofit/>
          </a:bodyPr>
          <a:lstStyle/>
          <a:p>
            <a:r>
              <a:rPr lang="en-US" dirty="0" smtClean="0"/>
              <a:t>5. LACTOSE-FREE DIETS:  </a:t>
            </a:r>
            <a:br>
              <a:rPr lang="en-US" dirty="0" smtClean="0"/>
            </a:br>
            <a:r>
              <a:rPr lang="en-US" dirty="0" smtClean="0"/>
              <a:t>COMMERCIAL/SPECIALIZED INGREDIENTS VS. 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5.2 STOOL OUTPUT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57400"/>
            <a:ext cx="9144000" cy="2738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321997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7"/>
            <a:ext cx="9144000" cy="1319191"/>
          </a:xfrm>
        </p:spPr>
        <p:txBody>
          <a:bodyPr>
            <a:noAutofit/>
          </a:bodyPr>
          <a:lstStyle/>
          <a:p>
            <a:r>
              <a:rPr lang="en-US" dirty="0" smtClean="0"/>
              <a:t>5. LACTOSE-FREE DIETS:  </a:t>
            </a:r>
            <a:br>
              <a:rPr lang="en-US" dirty="0" smtClean="0"/>
            </a:br>
            <a:r>
              <a:rPr lang="en-US" dirty="0" smtClean="0"/>
              <a:t>COMMERCIAL/SPECIALIZED INGREDIENTS VS. 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5.3 WEIGHT CHANGE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57400"/>
            <a:ext cx="9144000" cy="2738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24393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0" y="274638"/>
            <a:ext cx="8229600" cy="1143000"/>
          </a:xfrm>
        </p:spPr>
        <p:txBody>
          <a:bodyPr>
            <a:normAutofit/>
          </a:bodyPr>
          <a:lstStyle/>
          <a:p>
            <a:pPr algn="l"/>
            <a:r>
              <a:rPr lang="en-US" sz="2000" dirty="0" smtClean="0"/>
              <a:t>1. LIQUID FEEDS: REDUCED LACTOSE VS. REGULAR LACTOSE</a:t>
            </a:r>
            <a:br>
              <a:rPr lang="en-US" sz="2000" dirty="0" smtClean="0"/>
            </a:br>
            <a:r>
              <a:rPr lang="en-US" sz="2000" dirty="0" smtClean="0"/>
              <a:t/>
            </a:r>
            <a:br>
              <a:rPr lang="en-US" sz="2000" dirty="0" smtClean="0"/>
            </a:br>
            <a:r>
              <a:rPr lang="en-US" sz="2000" dirty="0" smtClean="0"/>
              <a:t>1.2 STOOL OUTPUT</a:t>
            </a:r>
            <a:endParaRPr lang="en-US" sz="2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66900"/>
            <a:ext cx="9144000" cy="3102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76110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274637"/>
            <a:ext cx="9144000" cy="1345107"/>
          </a:xfrm>
        </p:spPr>
        <p:txBody>
          <a:bodyPr>
            <a:noAutofit/>
          </a:bodyPr>
          <a:lstStyle/>
          <a:p>
            <a:r>
              <a:rPr lang="en-US" dirty="0" smtClean="0"/>
              <a:t>5. LACTOSE-FREE DIETS:  </a:t>
            </a:r>
            <a:br>
              <a:rPr lang="en-US" dirty="0" smtClean="0"/>
            </a:br>
            <a:r>
              <a:rPr lang="en-US" dirty="0" smtClean="0"/>
              <a:t>COMMERCIAL/SPECIALIZED INGREDIENTS VS. HOME-AVAILABLE INGREDIEN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5.4 TREATMENT FAILUR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95396"/>
            <a:ext cx="9144000" cy="3358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47527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2000" dirty="0" smtClean="0"/>
              <a:t>1. LIQUID FEEDS: REDUCED LACTOSE VS. REGULAR LACTOSE</a:t>
            </a:r>
            <a:br>
              <a:rPr lang="en-US" sz="2000" dirty="0" smtClean="0"/>
            </a:br>
            <a:r>
              <a:rPr lang="en-US" sz="2000" dirty="0" smtClean="0"/>
              <a:t/>
            </a:r>
            <a:br>
              <a:rPr lang="en-US" sz="2000" dirty="0" smtClean="0"/>
            </a:br>
            <a:r>
              <a:rPr lang="en-US" sz="2000" dirty="0" smtClean="0"/>
              <a:t>1.3 WEIGHT CHANGE</a:t>
            </a:r>
            <a:endParaRPr lang="en-US" sz="20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55800"/>
            <a:ext cx="9144000" cy="2939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21853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LIQUID FEEDS: REDUCED LACTOSE VS. REGULAR LACTOSE</a:t>
            </a:r>
            <a:br>
              <a:rPr lang="en-US" dirty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1.4 TREATMENT FAILURE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42428"/>
            <a:ext cx="9144000" cy="3981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2831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. LIQUID FEEDS: LACTOSE-FREE VS. LACTOSE-CONTAINING</a:t>
            </a:r>
            <a:br>
              <a:rPr lang="en-US" dirty="0" smtClean="0"/>
            </a:br>
            <a:r>
              <a:rPr lang="en-US" dirty="0"/>
              <a:t/>
            </a:r>
            <a:br>
              <a:rPr lang="en-US" dirty="0"/>
            </a:br>
            <a:r>
              <a:rPr lang="en-US" dirty="0" smtClean="0"/>
              <a:t>2.1 DURATION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47900"/>
            <a:ext cx="9144000" cy="23471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26959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. LIQUID FEEDS: LACTOSE-FREE VS. LACTOSE-CONTAINING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2.2 STOOL OUTPUT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87600"/>
            <a:ext cx="9144000" cy="2067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01059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. LIQUID FEEDS: LACTOSE-FREE VS. LACTOSE-CONTAINING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2.3 WEIGHT GA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30400"/>
            <a:ext cx="9144000" cy="2989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11884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. LIQUID FEEDS: LACTOSE-FREE VS. LACTOSE-CONTAINING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2.4 TREATMENT FAILURE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46200"/>
            <a:ext cx="9144000" cy="4157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97661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</a:t>
            </a:r>
            <a:r>
              <a:rPr lang="en-US" dirty="0" smtClean="0"/>
              <a:t>. LACTOSE-FREE LIQUID FEEDS VS. LACTOSE-CONTAINING MIXED DIETS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3.1 DURATION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97100"/>
            <a:ext cx="9144000" cy="24625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79215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228</Words>
  <Application>Microsoft Macintosh PowerPoint</Application>
  <PresentationFormat>On-screen Show (4:3)</PresentationFormat>
  <Paragraphs>20</Paragraphs>
  <Slides>2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1. LIQUID FEEDS: REDUCED LACTOSE VS. REGULAR LACTOSE  1.1 DURATION</vt:lpstr>
      <vt:lpstr>1. LIQUID FEEDS: REDUCED LACTOSE VS. REGULAR LACTOSE  1.2 STOOL OUTPUT</vt:lpstr>
      <vt:lpstr>1. LIQUID FEEDS: REDUCED LACTOSE VS. REGULAR LACTOSE  1.3 WEIGHT CHANGE</vt:lpstr>
      <vt:lpstr>1. LIQUID FEEDS: REDUCED LACTOSE VS. REGULAR LACTOSE  1.4 TREATMENT FAILURE</vt:lpstr>
      <vt:lpstr>2. LIQUID FEEDS: LACTOSE-FREE VS. LACTOSE-CONTAINING  2.1 DURATION</vt:lpstr>
      <vt:lpstr>2. LIQUID FEEDS: LACTOSE-FREE VS. LACTOSE-CONTAINING  2.2 STOOL OUTPUT</vt:lpstr>
      <vt:lpstr>2. LIQUID FEEDS: LACTOSE-FREE VS. LACTOSE-CONTAINING  2.3 WEIGHT GAIN</vt:lpstr>
      <vt:lpstr>2. LIQUID FEEDS: LACTOSE-FREE VS. LACTOSE-CONTAINING  2.4 TREATMENT FAILURE</vt:lpstr>
      <vt:lpstr>3. LACTOSE-FREE LIQUID FEEDS VS. LACTOSE-CONTAINING MIXED DIETS  3.1 DURATION</vt:lpstr>
      <vt:lpstr>3. LACTOSE-FREE LIQUID FEEDS VS. LACTOSE-CONTAINING MIXED DIETS  3.2 STOOL OUTPUT</vt:lpstr>
      <vt:lpstr>3. LACTOSE-FREE LIQUID FEEDS VS. LACTOSE-CONTAINING MIXED DIETS  3.3 WEIGHT GAIN</vt:lpstr>
      <vt:lpstr>3. LACTOSE-FREE LIQUID FEEDS VS. LACTOSE-CONTAINING MIXED DIETS  3.4 TREATMENT FAILURE</vt:lpstr>
      <vt:lpstr>4. COMMERCIAL/SPECIALIZED INGREDIENTS VS. HOME-AVAILABLE INGREDIENTS  4.1 DURATION</vt:lpstr>
      <vt:lpstr>4. COMMERCIAL/SPECIALIZED INGREDIENTS VS. HOME-AVAILABLE INGREDIENTS  4.2 STOOL OUTPUT</vt:lpstr>
      <vt:lpstr>4. COMMERCIAL/SPECIALIZED INGREDIENTS VS. HOME-AVAILABLE INGREDIENTS  4.3 WEIGHT GAIN</vt:lpstr>
      <vt:lpstr>4. COMMERCIAL/SPECIALIZED INGREDIENTS VS. HOME-AVAILABLE INGREDIENTS  4.4 TREATMENT FAILURE</vt:lpstr>
      <vt:lpstr>5. LACTOSE-FREE DIETS:   COMMERCIAL/SPECIALIZED INGREDIENTS VS. HOME-AVAILABLE INGREDIENTS  5.1 DURATION</vt:lpstr>
      <vt:lpstr>5. LACTOSE-FREE DIETS:   COMMERCIAL/SPECIALIZED INGREDIENTS VS. HOME-AVAILABLE INGREDIENTS  5.2 STOOL OUTPUT</vt:lpstr>
      <vt:lpstr>5. LACTOSE-FREE DIETS:   COMMERCIAL/SPECIALIZED INGREDIENTS VS. HOME-AVAILABLE INGREDIENTS  5.3 WEIGHT CHANGE</vt:lpstr>
      <vt:lpstr>5. LACTOSE-FREE DIETS:   COMMERCIAL/SPECIALIZED INGREDIENTS VS. HOME-AVAILABLE INGREDIENTS  5.4 TREATMENT FAILURE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lle Gaffey</dc:creator>
  <cp:lastModifiedBy>Michelle Gaffey</cp:lastModifiedBy>
  <cp:revision>6</cp:revision>
  <dcterms:created xsi:type="dcterms:W3CDTF">2012-09-14T01:09:03Z</dcterms:created>
  <dcterms:modified xsi:type="dcterms:W3CDTF">2013-02-18T23:02:29Z</dcterms:modified>
</cp:coreProperties>
</file>